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0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2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07C7F-78A6-40D6-9796-BD398FBC3D5A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C9B48-B2BE-4E89-8E4E-68EB444C0F7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625597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07C7F-78A6-40D6-9796-BD398FBC3D5A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C9B48-B2BE-4E89-8E4E-68EB444C0F7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373931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07C7F-78A6-40D6-9796-BD398FBC3D5A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C9B48-B2BE-4E89-8E4E-68EB444C0F7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840323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07C7F-78A6-40D6-9796-BD398FBC3D5A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C9B48-B2BE-4E89-8E4E-68EB444C0F7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191803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07C7F-78A6-40D6-9796-BD398FBC3D5A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C9B48-B2BE-4E89-8E4E-68EB444C0F7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084960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07C7F-78A6-40D6-9796-BD398FBC3D5A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C9B48-B2BE-4E89-8E4E-68EB444C0F7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45194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07C7F-78A6-40D6-9796-BD398FBC3D5A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C9B48-B2BE-4E89-8E4E-68EB444C0F7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439016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07C7F-78A6-40D6-9796-BD398FBC3D5A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C9B48-B2BE-4E89-8E4E-68EB444C0F7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807635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07C7F-78A6-40D6-9796-BD398FBC3D5A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C9B48-B2BE-4E89-8E4E-68EB444C0F7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937634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07C7F-78A6-40D6-9796-BD398FBC3D5A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C9B48-B2BE-4E89-8E4E-68EB444C0F7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753944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07C7F-78A6-40D6-9796-BD398FBC3D5A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C9B48-B2BE-4E89-8E4E-68EB444C0F7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475604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A07C7F-78A6-40D6-9796-BD398FBC3D5A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FC9B48-B2BE-4E89-8E4E-68EB444C0F7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051907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40767" y="1711532"/>
            <a:ext cx="3467804" cy="2643467"/>
          </a:xfrm>
          <a:prstGeom prst="rect">
            <a:avLst/>
          </a:prstGeom>
        </p:spPr>
      </p:pic>
      <p:pic>
        <p:nvPicPr>
          <p:cNvPr id="6" name="Imagen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546" t="17157" r="33458" b="74565"/>
          <a:stretch/>
        </p:blipFill>
        <p:spPr>
          <a:xfrm>
            <a:off x="1809221" y="2718496"/>
            <a:ext cx="1243383" cy="54863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CuadroTexto 6"/>
          <p:cNvSpPr txBox="1"/>
          <p:nvPr/>
        </p:nvSpPr>
        <p:spPr>
          <a:xfrm>
            <a:off x="3054511" y="2876668"/>
            <a:ext cx="6335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RPS25</a:t>
            </a:r>
          </a:p>
        </p:txBody>
      </p:sp>
      <p:pic>
        <p:nvPicPr>
          <p:cNvPr id="9" name="Imagen 8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551" t="70036" r="26233" b="23988"/>
          <a:stretch/>
        </p:blipFill>
        <p:spPr>
          <a:xfrm>
            <a:off x="1809221" y="3344629"/>
            <a:ext cx="1243383" cy="36624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CuadroTexto 9"/>
          <p:cNvSpPr txBox="1"/>
          <p:nvPr/>
        </p:nvSpPr>
        <p:spPr>
          <a:xfrm>
            <a:off x="3052604" y="3396948"/>
            <a:ext cx="8354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Beta-Actin</a:t>
            </a:r>
          </a:p>
        </p:txBody>
      </p:sp>
      <p:sp>
        <p:nvSpPr>
          <p:cNvPr id="11" name="TextBox 48">
            <a:extLst>
              <a:ext uri="{FF2B5EF4-FFF2-40B4-BE49-F238E27FC236}">
                <a16:creationId xmlns:a16="http://schemas.microsoft.com/office/drawing/2014/main" id="{214C2665-F6DB-6540-B1F1-CE06C728F809}"/>
              </a:ext>
            </a:extLst>
          </p:cNvPr>
          <p:cNvSpPr txBox="1"/>
          <p:nvPr/>
        </p:nvSpPr>
        <p:spPr>
          <a:xfrm>
            <a:off x="4200509" y="1711532"/>
            <a:ext cx="310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TextBox 48">
            <a:extLst>
              <a:ext uri="{FF2B5EF4-FFF2-40B4-BE49-F238E27FC236}">
                <a16:creationId xmlns:a16="http://schemas.microsoft.com/office/drawing/2014/main" id="{214C2665-F6DB-6540-B1F1-CE06C728F809}"/>
              </a:ext>
            </a:extLst>
          </p:cNvPr>
          <p:cNvSpPr txBox="1"/>
          <p:nvPr/>
        </p:nvSpPr>
        <p:spPr>
          <a:xfrm>
            <a:off x="1555999" y="1711532"/>
            <a:ext cx="310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" name="CuadroTexto 14"/>
          <p:cNvSpPr txBox="1"/>
          <p:nvPr/>
        </p:nvSpPr>
        <p:spPr>
          <a:xfrm>
            <a:off x="1943682" y="247174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</a:p>
        </p:txBody>
      </p:sp>
      <p:sp>
        <p:nvSpPr>
          <p:cNvPr id="16" name="CuadroTexto 15"/>
          <p:cNvSpPr txBox="1"/>
          <p:nvPr/>
        </p:nvSpPr>
        <p:spPr>
          <a:xfrm>
            <a:off x="2519051" y="2471742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168h</a:t>
            </a:r>
          </a:p>
        </p:txBody>
      </p:sp>
      <p:sp>
        <p:nvSpPr>
          <p:cNvPr id="25" name="TextBox 22">
            <a:extLst>
              <a:ext uri="{FF2B5EF4-FFF2-40B4-BE49-F238E27FC236}">
                <a16:creationId xmlns:a16="http://schemas.microsoft.com/office/drawing/2014/main" id="{CCFDFA84-E0B1-47C6-BD4D-4B9E9C76AB39}"/>
              </a:ext>
            </a:extLst>
          </p:cNvPr>
          <p:cNvSpPr txBox="1"/>
          <p:nvPr/>
        </p:nvSpPr>
        <p:spPr>
          <a:xfrm>
            <a:off x="1146658" y="4669465"/>
            <a:ext cx="676191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5. RPS25 expression and stability upon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transdifferentiation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) RPS25 immunoblot showing changes in protein expression upon 0 and 168 hours of transdifferentiation. (B)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ctinomyci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hase assay showing the RPS25 mRNA decay at 0 and 168 hours of BLaER1 transdifferentiation. 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T-Student test (P-Value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Significances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: * &lt; 0.05, ** &lt; 0.001, *** &lt; 0.0001)</a:t>
            </a:r>
            <a:endParaRPr lang="es-E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1938864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</TotalTime>
  <Words>72</Words>
  <Application>Microsoft Office PowerPoint</Application>
  <PresentationFormat>Presentación en pantalla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berto Bueno</dc:creator>
  <cp:lastModifiedBy>Manel Esteller</cp:lastModifiedBy>
  <cp:revision>8</cp:revision>
  <dcterms:created xsi:type="dcterms:W3CDTF">2022-03-31T18:31:05Z</dcterms:created>
  <dcterms:modified xsi:type="dcterms:W3CDTF">2022-04-05T17:50:18Z</dcterms:modified>
</cp:coreProperties>
</file>